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04DC8C-0A77-41C5-B53B-A4D3DCF63BC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202498-4F3A-49AC-9CCA-06F023A1240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5B51DD-9A9A-494C-B582-D1FCF919C9E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C3DAEA-3C5F-4DA8-833B-87983E9B59C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21AAB0-0091-48DD-89D6-0BEBACDFD2F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0C835B-2808-4152-8E13-3BB81AA91C3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469848-01F7-4E0C-9904-4E227F18FEB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F7DFC1-BC63-49CB-B996-3A57E9794A5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937B46-83B9-417E-8EBB-D51A9FE8CDD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8D6BD3-CD56-40CF-82ED-BC0642DDDDE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3FA06A-FFC1-4688-850B-EA4C96FC121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E9CF43-3DCF-48FE-982E-EC9C12164E7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D597167-AAC5-4C05-B816-451BC634EABC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903240" y="7894800"/>
            <a:ext cx="18432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"/>
          <p:cNvSpPr/>
          <p:nvPr/>
        </p:nvSpPr>
        <p:spPr>
          <a:xfrm>
            <a:off x="674640" y="7785000"/>
            <a:ext cx="5796000" cy="1037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Water consumed and locomotor activity. A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Water consumed (ml) over 70 hours of 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20-wk-old female POKO, ob/ob, PPAR</a:t>
            </a:r>
            <a:r>
              <a:rPr b="0" lang="en-GB" sz="10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2 KO and WT mice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.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.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verage total locomotor activity over 70 h (sampled every 5 min) at 20wk of age (n=3-4).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.  Average total locomotor activity over 70 h (sampled every 5 min) at 6wk of age (n=6-8). Mice were individually housed in the comprehensive laboratory animal monitoring system (CLAMs). Error bars show standard error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** p≤0.01 POKO </a:t>
            </a:r>
            <a:r>
              <a:rPr b="0" i="1" lang="en-GB" sz="1000" spc="-1" strike="noStrike">
                <a:solidFill>
                  <a:srgbClr val="000000"/>
                </a:solidFill>
                <a:latin typeface="Arial"/>
              </a:rPr>
              <a:t>vs.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 ob/ob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"/>
          <p:cNvSpPr/>
          <p:nvPr/>
        </p:nvSpPr>
        <p:spPr>
          <a:xfrm>
            <a:off x="5646240" y="8531280"/>
            <a:ext cx="87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 S2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44" name=""/>
          <p:cNvGrpSpPr/>
          <p:nvPr/>
        </p:nvGrpSpPr>
        <p:grpSpPr>
          <a:xfrm>
            <a:off x="1209960" y="2908440"/>
            <a:ext cx="3579480" cy="2281320"/>
            <a:chOff x="1209960" y="2908440"/>
            <a:chExt cx="3579480" cy="2281320"/>
          </a:xfrm>
        </p:grpSpPr>
        <p:sp>
          <p:nvSpPr>
            <p:cNvPr id="45" name=""/>
            <p:cNvSpPr/>
            <p:nvPr/>
          </p:nvSpPr>
          <p:spPr>
            <a:xfrm>
              <a:off x="1209960" y="2908440"/>
              <a:ext cx="375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2524320" y="4197240"/>
              <a:ext cx="222120" cy="7347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2519280" y="4190760"/>
              <a:ext cx="222480" cy="73656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3738600" y="3876480"/>
              <a:ext cx="220680" cy="10555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3732120" y="3870360"/>
              <a:ext cx="222480" cy="105696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2746440" y="4346640"/>
              <a:ext cx="220680" cy="585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2741760" y="4341600"/>
              <a:ext cx="220680" cy="58572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3959280" y="4068720"/>
              <a:ext cx="222120" cy="863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3954600" y="4064040"/>
              <a:ext cx="220680" cy="8632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2967120" y="4575240"/>
              <a:ext cx="219240" cy="35676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2962440" y="4570200"/>
              <a:ext cx="218880" cy="35712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4181400" y="4443480"/>
              <a:ext cx="219240" cy="48852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4175280" y="4438440"/>
              <a:ext cx="220680" cy="4888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3186360" y="4527360"/>
              <a:ext cx="222120" cy="40464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3181320" y="4522680"/>
              <a:ext cx="220680" cy="40464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4400640" y="4608360"/>
              <a:ext cx="222120" cy="32364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4395960" y="4603680"/>
              <a:ext cx="222120" cy="32364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" name=""/>
            <p:cNvSpPr/>
            <p:nvPr/>
          </p:nvSpPr>
          <p:spPr>
            <a:xfrm flipV="1">
              <a:off x="2629080" y="3963600"/>
              <a:ext cx="0" cy="226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2595600" y="3962160"/>
              <a:ext cx="698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" name=""/>
            <p:cNvSpPr/>
            <p:nvPr/>
          </p:nvSpPr>
          <p:spPr>
            <a:xfrm flipV="1">
              <a:off x="3841920" y="3517920"/>
              <a:ext cx="1440" cy="352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3808440" y="3517920"/>
              <a:ext cx="6984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" name=""/>
            <p:cNvSpPr/>
            <p:nvPr/>
          </p:nvSpPr>
          <p:spPr>
            <a:xfrm flipV="1">
              <a:off x="2851200" y="4122360"/>
              <a:ext cx="1440" cy="218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2817720" y="4122720"/>
              <a:ext cx="69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" name=""/>
            <p:cNvSpPr/>
            <p:nvPr/>
          </p:nvSpPr>
          <p:spPr>
            <a:xfrm flipV="1">
              <a:off x="4062600" y="3759120"/>
              <a:ext cx="1440" cy="304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4029120" y="3759120"/>
              <a:ext cx="6984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" name=""/>
            <p:cNvSpPr/>
            <p:nvPr/>
          </p:nvSpPr>
          <p:spPr>
            <a:xfrm flipV="1">
              <a:off x="3071880" y="4518000"/>
              <a:ext cx="0" cy="51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040" bIns="5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3036960" y="4518000"/>
              <a:ext cx="6984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" name=""/>
            <p:cNvSpPr/>
            <p:nvPr/>
          </p:nvSpPr>
          <p:spPr>
            <a:xfrm flipV="1">
              <a:off x="4284720" y="4336560"/>
              <a:ext cx="0" cy="1011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4251240" y="4336920"/>
              <a:ext cx="6984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" name=""/>
            <p:cNvSpPr/>
            <p:nvPr/>
          </p:nvSpPr>
          <p:spPr>
            <a:xfrm flipV="1">
              <a:off x="3289320" y="4494240"/>
              <a:ext cx="1800" cy="28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3256200" y="4494240"/>
              <a:ext cx="6984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" name=""/>
            <p:cNvSpPr/>
            <p:nvPr/>
          </p:nvSpPr>
          <p:spPr>
            <a:xfrm flipV="1">
              <a:off x="4505400" y="4578120"/>
              <a:ext cx="1440" cy="252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4471920" y="4578120"/>
              <a:ext cx="698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2359080" y="3328920"/>
              <a:ext cx="1440" cy="1603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2325600" y="4932360"/>
              <a:ext cx="33480" cy="10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2325600" y="4611600"/>
              <a:ext cx="33480" cy="10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2325600" y="4290840"/>
              <a:ext cx="3348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2325600" y="3970080"/>
              <a:ext cx="3348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2325600" y="3649680"/>
              <a:ext cx="33480" cy="10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2325600" y="3328920"/>
              <a:ext cx="33480" cy="10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2359080" y="4932360"/>
              <a:ext cx="242892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" name=""/>
            <p:cNvSpPr/>
            <p:nvPr/>
          </p:nvSpPr>
          <p:spPr>
            <a:xfrm flipV="1">
              <a:off x="2359080" y="4932000"/>
              <a:ext cx="1440" cy="3276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" name=""/>
            <p:cNvSpPr/>
            <p:nvPr/>
          </p:nvSpPr>
          <p:spPr>
            <a:xfrm flipV="1">
              <a:off x="3573360" y="4932000"/>
              <a:ext cx="1800" cy="3276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" name=""/>
            <p:cNvSpPr/>
            <p:nvPr/>
          </p:nvSpPr>
          <p:spPr>
            <a:xfrm flipV="1">
              <a:off x="4788000" y="4932000"/>
              <a:ext cx="1440" cy="3276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2211120" y="487656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1951560" y="4556160"/>
              <a:ext cx="35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250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1951560" y="4236840"/>
              <a:ext cx="35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500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1951560" y="3916440"/>
              <a:ext cx="35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750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1888200" y="3595680"/>
              <a:ext cx="421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000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1888200" y="3273480"/>
              <a:ext cx="421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250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2851200" y="5037120"/>
              <a:ext cx="232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Day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4022640" y="5037120"/>
              <a:ext cx="325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Night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7" name=""/>
            <p:cNvSpPr/>
            <p:nvPr/>
          </p:nvSpPr>
          <p:spPr>
            <a:xfrm rot="16200000">
              <a:off x="830880" y="3875760"/>
              <a:ext cx="1681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Total activity (Beam breaks)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98" name=""/>
          <p:cNvSpPr/>
          <p:nvPr/>
        </p:nvSpPr>
        <p:spPr>
          <a:xfrm>
            <a:off x="5173560" y="2255760"/>
            <a:ext cx="69840" cy="684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"/>
          <p:cNvSpPr/>
          <p:nvPr/>
        </p:nvSpPr>
        <p:spPr>
          <a:xfrm>
            <a:off x="5170320" y="2252520"/>
            <a:ext cx="74880" cy="748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080" bIns="280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"/>
          <p:cNvSpPr/>
          <p:nvPr/>
        </p:nvSpPr>
        <p:spPr>
          <a:xfrm>
            <a:off x="5270760" y="2238480"/>
            <a:ext cx="197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1" name=""/>
          <p:cNvSpPr/>
          <p:nvPr/>
        </p:nvSpPr>
        <p:spPr>
          <a:xfrm>
            <a:off x="5173560" y="2416320"/>
            <a:ext cx="69840" cy="68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1240" bIns="212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"/>
          <p:cNvSpPr/>
          <p:nvPr/>
        </p:nvSpPr>
        <p:spPr>
          <a:xfrm>
            <a:off x="5170320" y="2413080"/>
            <a:ext cx="74880" cy="74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3" name=""/>
          <p:cNvSpPr/>
          <p:nvPr/>
        </p:nvSpPr>
        <p:spPr>
          <a:xfrm>
            <a:off x="5261400" y="2398680"/>
            <a:ext cx="683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PAR</a:t>
            </a:r>
            <a:r>
              <a:rPr b="1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2KO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4" name=""/>
          <p:cNvSpPr/>
          <p:nvPr/>
        </p:nvSpPr>
        <p:spPr>
          <a:xfrm>
            <a:off x="5173560" y="2576520"/>
            <a:ext cx="69840" cy="6840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5" name=""/>
          <p:cNvSpPr/>
          <p:nvPr/>
        </p:nvSpPr>
        <p:spPr>
          <a:xfrm>
            <a:off x="5170320" y="2573280"/>
            <a:ext cx="74880" cy="74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6" name=""/>
          <p:cNvSpPr/>
          <p:nvPr/>
        </p:nvSpPr>
        <p:spPr>
          <a:xfrm>
            <a:off x="5270400" y="2558880"/>
            <a:ext cx="3466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ob/ob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7" name=""/>
          <p:cNvSpPr/>
          <p:nvPr/>
        </p:nvSpPr>
        <p:spPr>
          <a:xfrm>
            <a:off x="5173560" y="2736720"/>
            <a:ext cx="69840" cy="6840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8" name=""/>
          <p:cNvSpPr/>
          <p:nvPr/>
        </p:nvSpPr>
        <p:spPr>
          <a:xfrm>
            <a:off x="5170320" y="2733840"/>
            <a:ext cx="74880" cy="74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9" name=""/>
          <p:cNvSpPr/>
          <p:nvPr/>
        </p:nvSpPr>
        <p:spPr>
          <a:xfrm>
            <a:off x="5270040" y="2719440"/>
            <a:ext cx="374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OKO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0" name=""/>
          <p:cNvSpPr/>
          <p:nvPr/>
        </p:nvSpPr>
        <p:spPr>
          <a:xfrm>
            <a:off x="2714760" y="2378160"/>
            <a:ext cx="314280" cy="1411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1" name=""/>
          <p:cNvSpPr/>
          <p:nvPr/>
        </p:nvSpPr>
        <p:spPr>
          <a:xfrm>
            <a:off x="2709720" y="2371680"/>
            <a:ext cx="314640" cy="1414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2" name=""/>
          <p:cNvSpPr/>
          <p:nvPr/>
        </p:nvSpPr>
        <p:spPr>
          <a:xfrm>
            <a:off x="3029040" y="2311560"/>
            <a:ext cx="311040" cy="207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3" name=""/>
          <p:cNvSpPr/>
          <p:nvPr/>
        </p:nvSpPr>
        <p:spPr>
          <a:xfrm>
            <a:off x="3024360" y="2306520"/>
            <a:ext cx="311040" cy="2066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4" name=""/>
          <p:cNvSpPr/>
          <p:nvPr/>
        </p:nvSpPr>
        <p:spPr>
          <a:xfrm>
            <a:off x="3340080" y="2381400"/>
            <a:ext cx="316080" cy="13788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5" name=""/>
          <p:cNvSpPr/>
          <p:nvPr/>
        </p:nvSpPr>
        <p:spPr>
          <a:xfrm>
            <a:off x="3335400" y="2378160"/>
            <a:ext cx="314280" cy="135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6" name=""/>
          <p:cNvSpPr/>
          <p:nvPr/>
        </p:nvSpPr>
        <p:spPr>
          <a:xfrm>
            <a:off x="3656160" y="1273320"/>
            <a:ext cx="309240" cy="124596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7" name=""/>
          <p:cNvSpPr/>
          <p:nvPr/>
        </p:nvSpPr>
        <p:spPr>
          <a:xfrm>
            <a:off x="3649680" y="1266840"/>
            <a:ext cx="311040" cy="12463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8" name=""/>
          <p:cNvSpPr/>
          <p:nvPr/>
        </p:nvSpPr>
        <p:spPr>
          <a:xfrm flipV="1">
            <a:off x="2865600" y="2332080"/>
            <a:ext cx="1440" cy="39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9" name=""/>
          <p:cNvSpPr/>
          <p:nvPr/>
        </p:nvSpPr>
        <p:spPr>
          <a:xfrm>
            <a:off x="2830680" y="2332080"/>
            <a:ext cx="712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0" name=""/>
          <p:cNvSpPr/>
          <p:nvPr/>
        </p:nvSpPr>
        <p:spPr>
          <a:xfrm flipV="1">
            <a:off x="3176640" y="2214360"/>
            <a:ext cx="1440" cy="9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1" name=""/>
          <p:cNvSpPr/>
          <p:nvPr/>
        </p:nvSpPr>
        <p:spPr>
          <a:xfrm>
            <a:off x="3141720" y="2214720"/>
            <a:ext cx="730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2" name=""/>
          <p:cNvSpPr/>
          <p:nvPr/>
        </p:nvSpPr>
        <p:spPr>
          <a:xfrm flipV="1">
            <a:off x="3490920" y="2340000"/>
            <a:ext cx="0" cy="38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3" name=""/>
          <p:cNvSpPr/>
          <p:nvPr/>
        </p:nvSpPr>
        <p:spPr>
          <a:xfrm>
            <a:off x="3454560" y="2340000"/>
            <a:ext cx="745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4" name=""/>
          <p:cNvSpPr/>
          <p:nvPr/>
        </p:nvSpPr>
        <p:spPr>
          <a:xfrm flipV="1">
            <a:off x="3805200" y="1035000"/>
            <a:ext cx="1800" cy="2318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5" name=""/>
          <p:cNvSpPr/>
          <p:nvPr/>
        </p:nvSpPr>
        <p:spPr>
          <a:xfrm>
            <a:off x="3768840" y="1035000"/>
            <a:ext cx="7452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6" name=""/>
          <p:cNvSpPr/>
          <p:nvPr/>
        </p:nvSpPr>
        <p:spPr>
          <a:xfrm>
            <a:off x="2475000" y="990720"/>
            <a:ext cx="1440" cy="1522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7" name=""/>
          <p:cNvSpPr/>
          <p:nvPr/>
        </p:nvSpPr>
        <p:spPr>
          <a:xfrm>
            <a:off x="2438280" y="2513160"/>
            <a:ext cx="367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8" name=""/>
          <p:cNvSpPr/>
          <p:nvPr/>
        </p:nvSpPr>
        <p:spPr>
          <a:xfrm>
            <a:off x="2438280" y="2208240"/>
            <a:ext cx="367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9" name=""/>
          <p:cNvSpPr/>
          <p:nvPr/>
        </p:nvSpPr>
        <p:spPr>
          <a:xfrm>
            <a:off x="2438280" y="1905120"/>
            <a:ext cx="367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0" name=""/>
          <p:cNvSpPr/>
          <p:nvPr/>
        </p:nvSpPr>
        <p:spPr>
          <a:xfrm>
            <a:off x="2438280" y="1598760"/>
            <a:ext cx="367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1" name=""/>
          <p:cNvSpPr/>
          <p:nvPr/>
        </p:nvSpPr>
        <p:spPr>
          <a:xfrm>
            <a:off x="2438280" y="1295280"/>
            <a:ext cx="3672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2" name=""/>
          <p:cNvSpPr/>
          <p:nvPr/>
        </p:nvSpPr>
        <p:spPr>
          <a:xfrm>
            <a:off x="2438280" y="990720"/>
            <a:ext cx="367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3" name=""/>
          <p:cNvSpPr/>
          <p:nvPr/>
        </p:nvSpPr>
        <p:spPr>
          <a:xfrm>
            <a:off x="2475000" y="2513160"/>
            <a:ext cx="17208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4" name=""/>
          <p:cNvSpPr/>
          <p:nvPr/>
        </p:nvSpPr>
        <p:spPr>
          <a:xfrm flipV="1">
            <a:off x="2475000" y="2512800"/>
            <a:ext cx="1440" cy="349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5" name=""/>
          <p:cNvSpPr/>
          <p:nvPr/>
        </p:nvSpPr>
        <p:spPr>
          <a:xfrm flipV="1">
            <a:off x="4195800" y="2512800"/>
            <a:ext cx="1440" cy="349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6" name=""/>
          <p:cNvSpPr/>
          <p:nvPr/>
        </p:nvSpPr>
        <p:spPr>
          <a:xfrm>
            <a:off x="2325240" y="246528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7" name=""/>
          <p:cNvSpPr/>
          <p:nvPr/>
        </p:nvSpPr>
        <p:spPr>
          <a:xfrm>
            <a:off x="2258640" y="215892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8" name=""/>
          <p:cNvSpPr/>
          <p:nvPr/>
        </p:nvSpPr>
        <p:spPr>
          <a:xfrm>
            <a:off x="2258640" y="185580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9" name=""/>
          <p:cNvSpPr/>
          <p:nvPr/>
        </p:nvSpPr>
        <p:spPr>
          <a:xfrm>
            <a:off x="2258640" y="154944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0" name=""/>
          <p:cNvSpPr/>
          <p:nvPr/>
        </p:nvSpPr>
        <p:spPr>
          <a:xfrm>
            <a:off x="2258640" y="124776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8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1" name=""/>
          <p:cNvSpPr/>
          <p:nvPr/>
        </p:nvSpPr>
        <p:spPr>
          <a:xfrm>
            <a:off x="2190240" y="941400"/>
            <a:ext cx="210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2" name=""/>
          <p:cNvSpPr/>
          <p:nvPr/>
        </p:nvSpPr>
        <p:spPr>
          <a:xfrm rot="16200000">
            <a:off x="1271880" y="1500120"/>
            <a:ext cx="16603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Water consumed/70hrs (ml)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3" name=""/>
          <p:cNvSpPr/>
          <p:nvPr/>
        </p:nvSpPr>
        <p:spPr>
          <a:xfrm>
            <a:off x="3854520" y="973080"/>
            <a:ext cx="288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4" name=""/>
          <p:cNvSpPr/>
          <p:nvPr/>
        </p:nvSpPr>
        <p:spPr>
          <a:xfrm>
            <a:off x="1319040" y="7984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45" name=""/>
          <p:cNvGrpSpPr/>
          <p:nvPr/>
        </p:nvGrpSpPr>
        <p:grpSpPr>
          <a:xfrm>
            <a:off x="1646280" y="5705640"/>
            <a:ext cx="2863080" cy="1750680"/>
            <a:chOff x="1646280" y="5705640"/>
            <a:chExt cx="2863080" cy="1750680"/>
          </a:xfrm>
        </p:grpSpPr>
        <p:sp>
          <p:nvSpPr>
            <p:cNvPr id="146" name=""/>
            <p:cNvSpPr/>
            <p:nvPr/>
          </p:nvSpPr>
          <p:spPr>
            <a:xfrm>
              <a:off x="2608200" y="6837120"/>
              <a:ext cx="289080" cy="37908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7" name=""/>
            <p:cNvSpPr/>
            <p:nvPr/>
          </p:nvSpPr>
          <p:spPr>
            <a:xfrm>
              <a:off x="2602080" y="6833880"/>
              <a:ext cx="290520" cy="3772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3613320" y="6622560"/>
              <a:ext cx="285840" cy="59364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3608640" y="6617880"/>
              <a:ext cx="285480" cy="5932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0" name=""/>
            <p:cNvSpPr/>
            <p:nvPr/>
          </p:nvSpPr>
          <p:spPr>
            <a:xfrm>
              <a:off x="2897280" y="6692400"/>
              <a:ext cx="287280" cy="52380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1" name=""/>
            <p:cNvSpPr/>
            <p:nvPr/>
          </p:nvSpPr>
          <p:spPr>
            <a:xfrm>
              <a:off x="2892600" y="6687720"/>
              <a:ext cx="287280" cy="52344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2" name=""/>
            <p:cNvSpPr/>
            <p:nvPr/>
          </p:nvSpPr>
          <p:spPr>
            <a:xfrm>
              <a:off x="3899160" y="6370200"/>
              <a:ext cx="287280" cy="84600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3" name=""/>
            <p:cNvSpPr/>
            <p:nvPr/>
          </p:nvSpPr>
          <p:spPr>
            <a:xfrm>
              <a:off x="3894120" y="6364080"/>
              <a:ext cx="287280" cy="8470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4" name=""/>
            <p:cNvSpPr/>
            <p:nvPr/>
          </p:nvSpPr>
          <p:spPr>
            <a:xfrm flipV="1">
              <a:off x="2747880" y="6773040"/>
              <a:ext cx="1800" cy="60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320" bIns="13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5" name=""/>
            <p:cNvSpPr/>
            <p:nvPr/>
          </p:nvSpPr>
          <p:spPr>
            <a:xfrm>
              <a:off x="2716200" y="6773400"/>
              <a:ext cx="666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6" name=""/>
            <p:cNvSpPr/>
            <p:nvPr/>
          </p:nvSpPr>
          <p:spPr>
            <a:xfrm flipV="1">
              <a:off x="3749760" y="6547680"/>
              <a:ext cx="1440" cy="694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2680" bIns="22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3718080" y="6548040"/>
              <a:ext cx="666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8" name=""/>
            <p:cNvSpPr/>
            <p:nvPr/>
          </p:nvSpPr>
          <p:spPr>
            <a:xfrm flipV="1">
              <a:off x="3033720" y="6629040"/>
              <a:ext cx="1800" cy="583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1520" bIns="11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9" name=""/>
            <p:cNvSpPr/>
            <p:nvPr/>
          </p:nvSpPr>
          <p:spPr>
            <a:xfrm>
              <a:off x="3002040" y="6629040"/>
              <a:ext cx="666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0" name=""/>
            <p:cNvSpPr/>
            <p:nvPr/>
          </p:nvSpPr>
          <p:spPr>
            <a:xfrm flipV="1">
              <a:off x="4037040" y="6311160"/>
              <a:ext cx="1800" cy="522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1" name=""/>
            <p:cNvSpPr/>
            <p:nvPr/>
          </p:nvSpPr>
          <p:spPr>
            <a:xfrm>
              <a:off x="4005360" y="6311520"/>
              <a:ext cx="666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2" name=""/>
            <p:cNvSpPr/>
            <p:nvPr/>
          </p:nvSpPr>
          <p:spPr>
            <a:xfrm>
              <a:off x="2394000" y="5865480"/>
              <a:ext cx="1440" cy="1350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3" name=""/>
            <p:cNvSpPr/>
            <p:nvPr/>
          </p:nvSpPr>
          <p:spPr>
            <a:xfrm>
              <a:off x="2367000" y="7216560"/>
              <a:ext cx="27000" cy="10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4" name=""/>
            <p:cNvSpPr/>
            <p:nvPr/>
          </p:nvSpPr>
          <p:spPr>
            <a:xfrm>
              <a:off x="2367000" y="6765480"/>
              <a:ext cx="2700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5" name=""/>
            <p:cNvSpPr/>
            <p:nvPr/>
          </p:nvSpPr>
          <p:spPr>
            <a:xfrm>
              <a:off x="2367000" y="6316200"/>
              <a:ext cx="2700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6" name=""/>
            <p:cNvSpPr/>
            <p:nvPr/>
          </p:nvSpPr>
          <p:spPr>
            <a:xfrm>
              <a:off x="2367000" y="5865480"/>
              <a:ext cx="27000" cy="10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7" name=""/>
            <p:cNvSpPr/>
            <p:nvPr/>
          </p:nvSpPr>
          <p:spPr>
            <a:xfrm>
              <a:off x="2394000" y="7216560"/>
              <a:ext cx="2008080" cy="1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8" name=""/>
            <p:cNvSpPr/>
            <p:nvPr/>
          </p:nvSpPr>
          <p:spPr>
            <a:xfrm flipV="1">
              <a:off x="2394000" y="7216560"/>
              <a:ext cx="1440" cy="266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160" bIns="-20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9" name=""/>
            <p:cNvSpPr/>
            <p:nvPr/>
          </p:nvSpPr>
          <p:spPr>
            <a:xfrm flipV="1">
              <a:off x="3398760" y="7216560"/>
              <a:ext cx="1800" cy="266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160" bIns="-20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0" name=""/>
            <p:cNvSpPr/>
            <p:nvPr/>
          </p:nvSpPr>
          <p:spPr>
            <a:xfrm flipV="1">
              <a:off x="4402080" y="7216560"/>
              <a:ext cx="1800" cy="266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160" bIns="-20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1" name=""/>
            <p:cNvSpPr/>
            <p:nvPr/>
          </p:nvSpPr>
          <p:spPr>
            <a:xfrm>
              <a:off x="2273040" y="716724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2" name=""/>
            <p:cNvSpPr/>
            <p:nvPr/>
          </p:nvSpPr>
          <p:spPr>
            <a:xfrm>
              <a:off x="1964520" y="6716520"/>
              <a:ext cx="35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250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3" name=""/>
            <p:cNvSpPr/>
            <p:nvPr/>
          </p:nvSpPr>
          <p:spPr>
            <a:xfrm>
              <a:off x="1964520" y="6268680"/>
              <a:ext cx="35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500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4" name=""/>
            <p:cNvSpPr/>
            <p:nvPr/>
          </p:nvSpPr>
          <p:spPr>
            <a:xfrm>
              <a:off x="1964520" y="5816160"/>
              <a:ext cx="35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750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5" name=""/>
            <p:cNvSpPr/>
            <p:nvPr/>
          </p:nvSpPr>
          <p:spPr>
            <a:xfrm>
              <a:off x="2688840" y="7303680"/>
              <a:ext cx="337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   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Day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6" name=""/>
            <p:cNvSpPr/>
            <p:nvPr/>
          </p:nvSpPr>
          <p:spPr>
            <a:xfrm>
              <a:off x="3679920" y="7303680"/>
              <a:ext cx="39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Night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7" name=""/>
            <p:cNvSpPr/>
            <p:nvPr/>
          </p:nvSpPr>
          <p:spPr>
            <a:xfrm rot="16200000">
              <a:off x="881640" y="6469920"/>
              <a:ext cx="1681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Total activity (Beam breaks)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8" name=""/>
            <p:cNvSpPr/>
            <p:nvPr/>
          </p:nvSpPr>
          <p:spPr>
            <a:xfrm>
              <a:off x="4029120" y="5883120"/>
              <a:ext cx="425520" cy="2757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9" name=""/>
            <p:cNvSpPr/>
            <p:nvPr/>
          </p:nvSpPr>
          <p:spPr>
            <a:xfrm>
              <a:off x="4054680" y="5920920"/>
              <a:ext cx="58680" cy="5688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080" bIns="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0" name=""/>
            <p:cNvSpPr/>
            <p:nvPr/>
          </p:nvSpPr>
          <p:spPr>
            <a:xfrm>
              <a:off x="4051440" y="5919480"/>
              <a:ext cx="63360" cy="6156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760" bIns="14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1" name=""/>
            <p:cNvSpPr/>
            <p:nvPr/>
          </p:nvSpPr>
          <p:spPr>
            <a:xfrm>
              <a:off x="4135320" y="5866920"/>
              <a:ext cx="346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ob/ob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2" name=""/>
            <p:cNvSpPr/>
            <p:nvPr/>
          </p:nvSpPr>
          <p:spPr>
            <a:xfrm>
              <a:off x="4054680" y="6060600"/>
              <a:ext cx="58680" cy="5688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080" bIns="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3" name=""/>
            <p:cNvSpPr/>
            <p:nvPr/>
          </p:nvSpPr>
          <p:spPr>
            <a:xfrm>
              <a:off x="4051440" y="6057720"/>
              <a:ext cx="63360" cy="6300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200" bIns="16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4" name=""/>
            <p:cNvSpPr/>
            <p:nvPr/>
          </p:nvSpPr>
          <p:spPr>
            <a:xfrm>
              <a:off x="4135320" y="6008400"/>
              <a:ext cx="374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OKO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5" name=""/>
            <p:cNvSpPr/>
            <p:nvPr/>
          </p:nvSpPr>
          <p:spPr>
            <a:xfrm>
              <a:off x="4110120" y="6195600"/>
              <a:ext cx="289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**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186" name=""/>
          <p:cNvSpPr/>
          <p:nvPr/>
        </p:nvSpPr>
        <p:spPr>
          <a:xfrm>
            <a:off x="2612160" y="3019320"/>
            <a:ext cx="1694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Locomotor activity 20 wk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7" name=""/>
          <p:cNvSpPr/>
          <p:nvPr/>
        </p:nvSpPr>
        <p:spPr>
          <a:xfrm>
            <a:off x="2561400" y="5467320"/>
            <a:ext cx="1623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Locomotor activity 6 wk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8" name=""/>
          <p:cNvSpPr/>
          <p:nvPr/>
        </p:nvSpPr>
        <p:spPr>
          <a:xfrm>
            <a:off x="1295280" y="55738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6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2-09T18:50:00Z</dcterms:created>
  <dc:creator>Antonio Vidal-Puig</dc:creator>
  <dc:description/>
  <dc:language>en-US</dc:language>
  <cp:lastModifiedBy>Antonio Vidal-Puig</cp:lastModifiedBy>
  <dcterms:modified xsi:type="dcterms:W3CDTF">2007-03-05T17:28:00Z</dcterms:modified>
  <cp:revision>66</cp:revision>
  <dc:subject/>
  <dc:title>PowerPoint Presentation</dc:title>
</cp:coreProperties>
</file>